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57" r:id="rId4"/>
    <p:sldId id="263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396" y="2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3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2365692" y="465934"/>
            <a:ext cx="16291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/>
              <a:t>Figure </a:t>
            </a:r>
            <a:r>
              <a:rPr lang="en-US" altLang="zh-CN" smtClean="0"/>
              <a:t>4C-U251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4952842" y="430679"/>
            <a:ext cx="17285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/>
              <a:t>Figure </a:t>
            </a:r>
            <a:r>
              <a:rPr lang="en-US" altLang="zh-CN" smtClean="0"/>
              <a:t>4C-LN229</a:t>
            </a:r>
            <a:endParaRPr lang="zh-CN" altLang="en-US" dirty="0"/>
          </a:p>
        </p:txBody>
      </p:sp>
      <p:pic>
        <p:nvPicPr>
          <p:cNvPr id="1028" name="Picture 4" descr="C:\Users\123\AppData\Local\Temp\企业微信截图_1615888273198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2165" y="896533"/>
            <a:ext cx="1880989" cy="1588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123\AppData\Local\Temp\企业微信截图_16158882916539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7149" y="2484856"/>
            <a:ext cx="2180315" cy="17861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123\AppData\Local\Temp\企业微信截图_16158883287541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1032481"/>
            <a:ext cx="2411185" cy="14786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123\AppData\Local\Temp\企业微信截图_16158883488634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9160" y="2512421"/>
            <a:ext cx="2160240" cy="1758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74046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3464807" y="908720"/>
            <a:ext cx="10600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/>
              <a:t>Figure </a:t>
            </a:r>
            <a:r>
              <a:rPr lang="en-US" altLang="zh-CN" smtClean="0"/>
              <a:t>6C</a:t>
            </a:r>
            <a:endParaRPr lang="zh-CN" altLang="en-US" dirty="0"/>
          </a:p>
        </p:txBody>
      </p:sp>
      <p:pic>
        <p:nvPicPr>
          <p:cNvPr id="3074" name="Picture 2" descr="C:\Users\123\AppData\Local\Temp\企业微信截图_16158887522938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8652" y="1412776"/>
            <a:ext cx="3672408" cy="25984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64377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/>
          <p:cNvSpPr/>
          <p:nvPr/>
        </p:nvSpPr>
        <p:spPr>
          <a:xfrm>
            <a:off x="5196624" y="387585"/>
            <a:ext cx="17173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/>
              <a:t>Figure </a:t>
            </a:r>
            <a:r>
              <a:rPr lang="en-US" altLang="zh-CN" smtClean="0"/>
              <a:t>6E-LN229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2338130" y="423834"/>
            <a:ext cx="16179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/>
              <a:t>Figure </a:t>
            </a:r>
            <a:r>
              <a:rPr lang="en-US" altLang="zh-CN" smtClean="0"/>
              <a:t>6E-U251</a:t>
            </a:r>
            <a:endParaRPr lang="zh-CN" altLang="en-US" dirty="0"/>
          </a:p>
        </p:txBody>
      </p:sp>
      <p:pic>
        <p:nvPicPr>
          <p:cNvPr id="2050" name="Picture 2" descr="C:\Users\123\AppData\Local\Temp\企业微信截图_16158884842318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965869"/>
            <a:ext cx="2638425" cy="17811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123\AppData\Local\Temp\企业微信截图_16158885008136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8181" y="2861661"/>
            <a:ext cx="2397390" cy="16647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123\AppData\Local\Temp\企业微信截图_16158885457844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1860" y="1016935"/>
            <a:ext cx="2509839" cy="16790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123\AppData\Local\Temp\企业微信截图_16158885702952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694" y="2827371"/>
            <a:ext cx="2412172" cy="1877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295610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611560" y="411369"/>
            <a:ext cx="13172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/>
              <a:t>Figure </a:t>
            </a:r>
            <a:r>
              <a:rPr lang="en-US" altLang="zh-CN" sz="1400" smtClean="0"/>
              <a:t>7A-U251</a:t>
            </a:r>
            <a:endParaRPr lang="zh-CN" altLang="en-US" sz="1400" dirty="0"/>
          </a:p>
        </p:txBody>
      </p:sp>
      <p:pic>
        <p:nvPicPr>
          <p:cNvPr id="1026" name="Picture 2" descr="C:\Users\123\AppData\Local\Temp\企业微信截图_1616134078928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9398" y="836711"/>
            <a:ext cx="1224136" cy="1570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123\AppData\Local\Temp\企业微信截图_16161341166085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412" y="2424578"/>
            <a:ext cx="972108" cy="12718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123\AppData\Local\Temp\企业微信截图_1616134153721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9359" y="798459"/>
            <a:ext cx="1034691" cy="15122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123\AppData\Local\Temp\企业微信截图_1616134177168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2426240"/>
            <a:ext cx="864096" cy="1329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123\AppData\Local\Temp\企业微信截图_1616134213751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7" y="836712"/>
            <a:ext cx="1465699" cy="1410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:\Users\123\AppData\Local\Temp\企业微信截图_16161342455338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8" y="2310700"/>
            <a:ext cx="1296144" cy="14813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Users\123\AppData\Local\Temp\企业微信截图_16161343068266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0152" y="2426240"/>
            <a:ext cx="1250661" cy="14329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123\AppData\Local\Temp\企业微信截图_16161343372751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942576"/>
            <a:ext cx="1322669" cy="14651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矩形 15"/>
          <p:cNvSpPr/>
          <p:nvPr/>
        </p:nvSpPr>
        <p:spPr>
          <a:xfrm>
            <a:off x="2051720" y="449140"/>
            <a:ext cx="13925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/>
              <a:t>Figure </a:t>
            </a:r>
            <a:r>
              <a:rPr lang="en-US" altLang="zh-CN" sz="1400" smtClean="0"/>
              <a:t>7A-LN229</a:t>
            </a:r>
            <a:endParaRPr lang="zh-CN" altLang="en-US" sz="1400" dirty="0"/>
          </a:p>
        </p:txBody>
      </p:sp>
      <p:sp>
        <p:nvSpPr>
          <p:cNvPr id="17" name="矩形 16"/>
          <p:cNvSpPr/>
          <p:nvPr/>
        </p:nvSpPr>
        <p:spPr>
          <a:xfrm>
            <a:off x="4015247" y="452756"/>
            <a:ext cx="1309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/>
              <a:t>Figure </a:t>
            </a:r>
            <a:r>
              <a:rPr lang="en-US" altLang="zh-CN" sz="1400" smtClean="0"/>
              <a:t>7C-U251</a:t>
            </a:r>
            <a:endParaRPr lang="zh-CN" altLang="en-US" sz="1400" dirty="0"/>
          </a:p>
        </p:txBody>
      </p:sp>
      <p:sp>
        <p:nvSpPr>
          <p:cNvPr id="18" name="矩形 17"/>
          <p:cNvSpPr/>
          <p:nvPr/>
        </p:nvSpPr>
        <p:spPr>
          <a:xfrm>
            <a:off x="5796136" y="452756"/>
            <a:ext cx="13845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/>
              <a:t>Figure </a:t>
            </a:r>
            <a:r>
              <a:rPr lang="en-US" altLang="zh-CN" sz="1400" smtClean="0"/>
              <a:t>7C-LN229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857534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18</Words>
  <Application>Microsoft Office PowerPoint</Application>
  <PresentationFormat>全屏显示(4:3)</PresentationFormat>
  <Paragraphs>9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23</dc:creator>
  <cp:lastModifiedBy>123</cp:lastModifiedBy>
  <cp:revision>9</cp:revision>
  <dcterms:created xsi:type="dcterms:W3CDTF">2020-09-16T02:14:22Z</dcterms:created>
  <dcterms:modified xsi:type="dcterms:W3CDTF">2021-03-19T06:14:57Z</dcterms:modified>
</cp:coreProperties>
</file>